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40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34FEB-FC2E-47DA-B3F1-0608BFEDFE8E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670E4-503B-4A4A-9665-6939CD97FC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593624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34FEB-FC2E-47DA-B3F1-0608BFEDFE8E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670E4-503B-4A4A-9665-6939CD97FC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795735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34FEB-FC2E-47DA-B3F1-0608BFEDFE8E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670E4-503B-4A4A-9665-6939CD97FC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087723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34FEB-FC2E-47DA-B3F1-0608BFEDFE8E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670E4-503B-4A4A-9665-6939CD97FC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85812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34FEB-FC2E-47DA-B3F1-0608BFEDFE8E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670E4-503B-4A4A-9665-6939CD97FC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739879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34FEB-FC2E-47DA-B3F1-0608BFEDFE8E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670E4-503B-4A4A-9665-6939CD97FC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71835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34FEB-FC2E-47DA-B3F1-0608BFEDFE8E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670E4-503B-4A4A-9665-6939CD97FC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476598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34FEB-FC2E-47DA-B3F1-0608BFEDFE8E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670E4-503B-4A4A-9665-6939CD97FC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72861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34FEB-FC2E-47DA-B3F1-0608BFEDFE8E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670E4-503B-4A4A-9665-6939CD97FC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885902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34FEB-FC2E-47DA-B3F1-0608BFEDFE8E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670E4-503B-4A4A-9665-6939CD97FC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22060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C34FEB-FC2E-47DA-B3F1-0608BFEDFE8E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1670E4-503B-4A4A-9665-6939CD97FC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8165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C34FEB-FC2E-47DA-B3F1-0608BFEDFE8E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1670E4-503B-4A4A-9665-6939CD97FCC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618710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/>
          <p:cNvPicPr>
            <a:picLocks noChangeAspect="1"/>
          </p:cNvPicPr>
          <p:nvPr/>
        </p:nvPicPr>
        <p:blipFill rotWithShape="1">
          <a:blip r:embed="rId2"/>
          <a:srcRect l="4244" t="9372" r="1217" b="17788"/>
          <a:stretch/>
        </p:blipFill>
        <p:spPr>
          <a:xfrm>
            <a:off x="335205" y="49800"/>
            <a:ext cx="11526253" cy="481030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CuadroTexto 4"/>
          <p:cNvSpPr txBox="1"/>
          <p:nvPr/>
        </p:nvSpPr>
        <p:spPr>
          <a:xfrm>
            <a:off x="0" y="49800"/>
            <a:ext cx="365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a)</a:t>
            </a:r>
            <a:endParaRPr lang="es-ES" dirty="0"/>
          </a:p>
        </p:txBody>
      </p:sp>
      <p:grpSp>
        <p:nvGrpSpPr>
          <p:cNvPr id="6" name="Grupo 5"/>
          <p:cNvGrpSpPr/>
          <p:nvPr/>
        </p:nvGrpSpPr>
        <p:grpSpPr>
          <a:xfrm>
            <a:off x="375630" y="5166005"/>
            <a:ext cx="6256020" cy="1310640"/>
            <a:chOff x="0" y="0"/>
            <a:chExt cx="8542568" cy="1663337"/>
          </a:xfrm>
        </p:grpSpPr>
        <p:pic>
          <p:nvPicPr>
            <p:cNvPr id="7" name="Imagen 6"/>
            <p:cNvPicPr>
              <a:picLocks noChangeAspect="1"/>
            </p:cNvPicPr>
            <p:nvPr/>
          </p:nvPicPr>
          <p:blipFill rotWithShape="1">
            <a:blip r:embed="rId3"/>
            <a:srcRect l="27570" t="18906" r="26944" b="64743"/>
            <a:stretch/>
          </p:blipFill>
          <p:spPr>
            <a:xfrm>
              <a:off x="0" y="0"/>
              <a:ext cx="8542568" cy="1663337"/>
            </a:xfrm>
            <a:prstGeom prst="rect">
              <a:avLst/>
            </a:prstGeom>
            <a:ln w="38100">
              <a:solidFill>
                <a:schemeClr val="tx1"/>
              </a:solidFill>
            </a:ln>
          </p:spPr>
        </p:pic>
        <p:pic>
          <p:nvPicPr>
            <p:cNvPr id="8" name="Imagen 7"/>
            <p:cNvPicPr>
              <a:picLocks noChangeAspect="1"/>
            </p:cNvPicPr>
            <p:nvPr/>
          </p:nvPicPr>
          <p:blipFill rotWithShape="1">
            <a:blip r:embed="rId3"/>
            <a:srcRect l="54798" t="25685" r="26944" b="72716"/>
            <a:stretch/>
          </p:blipFill>
          <p:spPr>
            <a:xfrm>
              <a:off x="5113567" y="1096070"/>
              <a:ext cx="3429001" cy="162562"/>
            </a:xfrm>
            <a:prstGeom prst="rect">
              <a:avLst/>
            </a:prstGeom>
            <a:ln w="38100">
              <a:noFill/>
            </a:ln>
          </p:spPr>
        </p:pic>
        <p:pic>
          <p:nvPicPr>
            <p:cNvPr id="9" name="Imagen 8"/>
            <p:cNvPicPr>
              <a:picLocks/>
            </p:cNvPicPr>
            <p:nvPr/>
          </p:nvPicPr>
          <p:blipFill rotWithShape="1">
            <a:blip r:embed="rId3"/>
            <a:srcRect l="32250" t="30380" r="56018" b="67736"/>
            <a:stretch/>
          </p:blipFill>
          <p:spPr>
            <a:xfrm>
              <a:off x="5074659" y="691365"/>
              <a:ext cx="3096000" cy="180000"/>
            </a:xfrm>
            <a:prstGeom prst="rect">
              <a:avLst/>
            </a:prstGeom>
            <a:noFill/>
            <a:ln w="38100">
              <a:noFill/>
            </a:ln>
          </p:spPr>
        </p:pic>
      </p:grpSp>
      <p:sp>
        <p:nvSpPr>
          <p:cNvPr id="10" name="CuadroTexto 9"/>
          <p:cNvSpPr txBox="1"/>
          <p:nvPr/>
        </p:nvSpPr>
        <p:spPr>
          <a:xfrm>
            <a:off x="0" y="5075550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b</a:t>
            </a:r>
            <a:r>
              <a:rPr lang="es-ES" dirty="0" smtClean="0"/>
              <a:t>)</a:t>
            </a:r>
            <a:endParaRPr lang="es-ES" dirty="0"/>
          </a:p>
        </p:txBody>
      </p:sp>
      <p:sp>
        <p:nvSpPr>
          <p:cNvPr id="11" name="CuadroTexto 10"/>
          <p:cNvSpPr txBox="1"/>
          <p:nvPr/>
        </p:nvSpPr>
        <p:spPr>
          <a:xfrm>
            <a:off x="8879081" y="6533922"/>
            <a:ext cx="31832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smtClean="0"/>
              <a:t>Figure 2</a:t>
            </a:r>
            <a:r>
              <a:rPr lang="es-ES" sz="1200" b="1" dirty="0" smtClean="0"/>
              <a:t>. </a:t>
            </a:r>
            <a:r>
              <a:rPr lang="es-ES" sz="1200" b="1" dirty="0" err="1" smtClean="0"/>
              <a:t>supplemental</a:t>
            </a:r>
            <a:r>
              <a:rPr lang="es-ES" sz="1200" b="1" dirty="0" smtClean="0"/>
              <a:t> data </a:t>
            </a:r>
            <a:r>
              <a:rPr lang="es-ES" sz="1200" b="1" dirty="0"/>
              <a:t>Nevado et al</a:t>
            </a:r>
            <a:r>
              <a:rPr lang="es-ES" sz="1200" b="1" dirty="0" smtClean="0"/>
              <a:t>.</a:t>
            </a:r>
            <a:endParaRPr lang="es-ES" sz="1200" b="1" dirty="0"/>
          </a:p>
        </p:txBody>
      </p:sp>
      <p:sp>
        <p:nvSpPr>
          <p:cNvPr id="2" name="Rectángulo 1"/>
          <p:cNvSpPr/>
          <p:nvPr/>
        </p:nvSpPr>
        <p:spPr>
          <a:xfrm>
            <a:off x="2418460" y="5444882"/>
            <a:ext cx="819602" cy="938985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2" name="Rectángulo 11"/>
          <p:cNvSpPr/>
          <p:nvPr/>
        </p:nvSpPr>
        <p:spPr>
          <a:xfrm>
            <a:off x="4412752" y="5383111"/>
            <a:ext cx="1356921" cy="938985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" name="Rectángulo 2"/>
          <p:cNvSpPr/>
          <p:nvPr/>
        </p:nvSpPr>
        <p:spPr>
          <a:xfrm>
            <a:off x="7392112" y="4833609"/>
            <a:ext cx="4469346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90170" algn="just">
              <a:lnSpc>
                <a:spcPct val="200000"/>
              </a:lnSpc>
              <a:spcAft>
                <a:spcPts val="0"/>
              </a:spcAft>
            </a:pPr>
            <a:r>
              <a:rPr lang="en-US" sz="9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2. Supplemental Data. </a:t>
            </a:r>
            <a:r>
              <a:rPr lang="en-US" sz="9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letions </a:t>
            </a:r>
            <a:r>
              <a:rPr lang="en-US" sz="9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lack bars) observed in individuals with 5p minus syndrome. Deletions include terminal deletions </a:t>
            </a:r>
            <a:r>
              <a:rPr lang="en-US" sz="9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9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9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</a:t>
            </a:r>
            <a:r>
              <a:rPr lang="en-US" sz="9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terstitial deletions </a:t>
            </a:r>
            <a:r>
              <a:rPr lang="en-US" sz="9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9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9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US" sz="9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location of 22q13 cytogenetic bands are also presented in this figure produced using the UCSC genome browser (Kent et al. 2002) using the 2009 (hg19; GRCh37) genome build (International Human Genome Sequencing Consortium 2009</a:t>
            </a:r>
            <a:r>
              <a:rPr lang="en-US" sz="9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Red square denoted potential SROs (small region overlapping) in interstitial cases.</a:t>
            </a:r>
            <a:endParaRPr lang="es-ES" sz="9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608008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2</TotalTime>
  <Words>101</Words>
  <Application>Microsoft Office PowerPoint</Application>
  <PresentationFormat>Panorámica</PresentationFormat>
  <Paragraphs>4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lian</dc:creator>
  <cp:lastModifiedBy>Julian</cp:lastModifiedBy>
  <cp:revision>40</cp:revision>
  <dcterms:created xsi:type="dcterms:W3CDTF">2020-12-19T11:29:01Z</dcterms:created>
  <dcterms:modified xsi:type="dcterms:W3CDTF">2021-03-22T17:16:27Z</dcterms:modified>
</cp:coreProperties>
</file>